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2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Vossen, Jack" initials="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80808"/>
    <a:srgbClr val="0000CC"/>
    <a:srgbClr val="FFCD2F"/>
    <a:srgbClr val="CCE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4314" autoAdjust="0"/>
    <p:restoredTop sz="89526" autoAdjust="0"/>
  </p:normalViewPr>
  <p:slideViewPr>
    <p:cSldViewPr snapToGrid="0">
      <p:cViewPr>
        <p:scale>
          <a:sx n="100" d="100"/>
          <a:sy n="100" d="100"/>
        </p:scale>
        <p:origin x="-1728" y="1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D4E7E4EC-C49D-4190-B24F-1B047866C128}" type="datetimeFigureOut">
              <a:rPr lang="en-GB"/>
              <a:pPr>
                <a:defRPr/>
              </a:pPr>
              <a:t>01/02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6682832A-CF56-4C18-B170-1647E858C8EA}" type="slidenum">
              <a:rPr lang="en-GB"/>
              <a:pPr>
                <a:defRPr/>
              </a:pPr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8284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BFF737-661F-45A5-841D-1D67A61F4EBE}" type="datetimeFigureOut">
              <a:rPr lang="en-GB"/>
              <a:pPr>
                <a:defRPr/>
              </a:pPr>
              <a:t>01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2D6922-4D2D-4279-9734-16A38CEC08E0}" type="slidenum">
              <a:rPr lang="en-GB"/>
              <a:pPr>
                <a:defRPr/>
              </a:pPr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94CF5E-1E26-42AC-97DE-E8A2C45F8F54}" type="datetimeFigureOut">
              <a:rPr lang="en-GB"/>
              <a:pPr>
                <a:defRPr/>
              </a:pPr>
              <a:t>01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31871C-73AA-4DDF-BB94-C0FFB5C2FBCA}" type="slidenum">
              <a:rPr lang="en-GB"/>
              <a:pPr>
                <a:defRPr/>
              </a:pPr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0AA0B7-DF5C-4AD2-B28C-897D219B1211}" type="datetimeFigureOut">
              <a:rPr lang="en-GB"/>
              <a:pPr>
                <a:defRPr/>
              </a:pPr>
              <a:t>01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84FDC2-3009-4AD4-B99B-294B31683A7F}" type="slidenum">
              <a:rPr lang="en-GB"/>
              <a:pPr>
                <a:defRPr/>
              </a:pPr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52A83E-09C6-4589-992F-D78104AE226B}" type="datetimeFigureOut">
              <a:rPr lang="en-GB"/>
              <a:pPr>
                <a:defRPr/>
              </a:pPr>
              <a:t>01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A45EC9-A378-4F48-B8A9-CFD73C3D486F}" type="slidenum">
              <a:rPr lang="en-GB"/>
              <a:pPr>
                <a:defRPr/>
              </a:pPr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9703AA-71E2-450C-AB1A-73EF55074413}" type="datetimeFigureOut">
              <a:rPr lang="en-GB"/>
              <a:pPr>
                <a:defRPr/>
              </a:pPr>
              <a:t>01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8F4EC9-A0BA-42C0-9FF4-32F777CE59C4}" type="slidenum">
              <a:rPr lang="en-GB"/>
              <a:pPr>
                <a:defRPr/>
              </a:pPr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8F9F03-55ED-40C4-9386-6D443357D13E}" type="datetimeFigureOut">
              <a:rPr lang="en-GB"/>
              <a:pPr>
                <a:defRPr/>
              </a:pPr>
              <a:t>01/02/2014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04651C-77E4-4FD2-A10E-BEAF31A97F8F}" type="slidenum">
              <a:rPr lang="en-GB"/>
              <a:pPr>
                <a:defRPr/>
              </a:pPr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AD9700-6FC5-4C71-B2F3-4E4C772AB9E1}" type="datetimeFigureOut">
              <a:rPr lang="en-GB"/>
              <a:pPr>
                <a:defRPr/>
              </a:pPr>
              <a:t>01/02/2014</a:t>
            </a:fld>
            <a:endParaRPr lang="en-GB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117456-3AA0-4919-AE5D-6B6384787636}" type="slidenum">
              <a:rPr lang="en-GB"/>
              <a:pPr>
                <a:defRPr/>
              </a:pPr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614AB9-A2A6-4F38-97D3-98FB7E113C69}" type="datetimeFigureOut">
              <a:rPr lang="en-GB"/>
              <a:pPr>
                <a:defRPr/>
              </a:pPr>
              <a:t>01/02/2014</a:t>
            </a:fld>
            <a:endParaRPr lang="en-GB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B80484-4E36-474B-A922-7D23D10715A2}" type="slidenum">
              <a:rPr lang="en-GB"/>
              <a:pPr>
                <a:defRPr/>
              </a:pPr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337E4E-E222-4DF3-8D44-ABD10C66DDEE}" type="datetimeFigureOut">
              <a:rPr lang="en-GB"/>
              <a:pPr>
                <a:defRPr/>
              </a:pPr>
              <a:t>01/02/2014</a:t>
            </a:fld>
            <a:endParaRPr lang="en-GB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0394E1-3C87-4E6E-9B33-BB332D751066}" type="slidenum">
              <a:rPr lang="en-GB"/>
              <a:pPr>
                <a:defRPr/>
              </a:pPr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255B37-178A-4A4B-9A7D-F1958ABB7A53}" type="datetimeFigureOut">
              <a:rPr lang="en-GB"/>
              <a:pPr>
                <a:defRPr/>
              </a:pPr>
              <a:t>01/02/2014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F6EF97-D49F-4390-AB5B-AC31488BA287}" type="slidenum">
              <a:rPr lang="en-GB"/>
              <a:pPr>
                <a:defRPr/>
              </a:pPr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4C5641-0F86-4D46-85D1-0745548602E3}" type="datetimeFigureOut">
              <a:rPr lang="en-GB"/>
              <a:pPr>
                <a:defRPr/>
              </a:pPr>
              <a:t>01/02/2014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0935C2-69F8-4440-ACFD-4E23F8E4E30C}" type="slidenum">
              <a:rPr lang="en-GB"/>
              <a:pPr>
                <a:defRPr/>
              </a:pPr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GB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69E2B2DB-02B9-4DFB-BCF2-7EB6C3407FD9}" type="datetimeFigureOut">
              <a:rPr lang="en-GB"/>
              <a:pPr>
                <a:defRPr/>
              </a:pPr>
              <a:t>01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E57F817A-13E9-48B5-8D2E-D90317DD37F6}" type="slidenum">
              <a:rPr lang="en-GB"/>
              <a:pPr>
                <a:defRPr/>
              </a:pPr>
              <a:t>‹nr.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2970" name="Group 20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1297099"/>
              </p:ext>
            </p:extLst>
          </p:nvPr>
        </p:nvGraphicFramePr>
        <p:xfrm>
          <a:off x="1524000" y="1397000"/>
          <a:ext cx="7053263" cy="2523744"/>
        </p:xfrm>
        <a:graphic>
          <a:graphicData uri="http://schemas.openxmlformats.org/drawingml/2006/table">
            <a:tbl>
              <a:tblPr/>
              <a:tblGrid>
                <a:gridCol w="1016000"/>
                <a:gridCol w="719138"/>
                <a:gridCol w="1304925"/>
                <a:gridCol w="668337"/>
                <a:gridCol w="1709738"/>
                <a:gridCol w="1635125"/>
              </a:tblGrid>
              <a:tr h="312738"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Isolate </a:t>
                      </a: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ID</a:t>
                      </a: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Isolation year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Country of </a:t>
                      </a: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origin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Mating </a:t>
                      </a: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type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Obtained from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Virulence profile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1138"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EC1</a:t>
                      </a: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—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Ecuador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—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Birch, SCRI, Scotland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1.3.4.7.10.11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1463"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IPO-C</a:t>
                      </a: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1982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Belgium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A2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Kessel, PRI, WUR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1.2.3.4.5.6.7.10.11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7038"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DHD11</a:t>
                      </a: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2011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Daehongdan, DPR Korea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—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RIA, DPR Korea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1.2.3.4.6.7.10.11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2413"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90128</a:t>
                      </a: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1990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Geldrop, </a:t>
                      </a: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The Nedtherlands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A2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Govers, Phytopathology WUR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1.3.4.7.8.10.11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0825"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PIC99189</a:t>
                      </a: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1999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Metepec,</a:t>
                      </a: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Mexico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A2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Kessel, PRI, WUR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1.2.5.7.10.11</a:t>
                      </a: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 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32821" name="Rectangle 53"/>
          <p:cNvSpPr>
            <a:spLocks noChangeArrowheads="1"/>
          </p:cNvSpPr>
          <p:nvPr/>
        </p:nvSpPr>
        <p:spPr bwMode="auto">
          <a:xfrm>
            <a:off x="2679700" y="1058863"/>
            <a:ext cx="5016500" cy="182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lIns="0" tIns="0" rIns="0" bIns="0" anchor="ctr">
            <a:spAutoFit/>
          </a:bodyPr>
          <a:lstStyle/>
          <a:p>
            <a:r>
              <a:rPr lang="en-GB" sz="1200" b="1" dirty="0">
                <a:latin typeface="Times New Roman" pitchFamily="18" charset="0"/>
              </a:rPr>
              <a:t>Additional file 2 – Characteristics of </a:t>
            </a:r>
            <a:r>
              <a:rPr lang="en-GB" sz="1200" b="1" i="1" dirty="0">
                <a:latin typeface="Times New Roman" pitchFamily="18" charset="0"/>
              </a:rPr>
              <a:t>P. </a:t>
            </a:r>
            <a:r>
              <a:rPr lang="en-GB" sz="1200" b="1" i="1" dirty="0" err="1">
                <a:latin typeface="Times New Roman" pitchFamily="18" charset="0"/>
              </a:rPr>
              <a:t>infestans</a:t>
            </a:r>
            <a:r>
              <a:rPr lang="en-GB" sz="1200" b="1" dirty="0">
                <a:latin typeface="Times New Roman" pitchFamily="18" charset="0"/>
              </a:rPr>
              <a:t> isolates used in this study</a:t>
            </a:r>
            <a:endParaRPr lang="en-GB" sz="1200" dirty="0">
              <a:latin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94</TotalTime>
  <Words>83</Words>
  <Application>Microsoft Office PowerPoint</Application>
  <PresentationFormat>Diavoorstelling (4:3)</PresentationFormat>
  <Paragraphs>56</Paragraphs>
  <Slides>1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Office Theme</vt:lpstr>
      <vt:lpstr>PowerPoint-presentatie</vt:lpstr>
    </vt:vector>
  </TitlesOfParts>
  <Company>Wageningen U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, Kwang Ryong</dc:creator>
  <cp:lastModifiedBy>Jack Vossen</cp:lastModifiedBy>
  <cp:revision>1019</cp:revision>
  <dcterms:created xsi:type="dcterms:W3CDTF">2012-07-22T10:01:28Z</dcterms:created>
  <dcterms:modified xsi:type="dcterms:W3CDTF">2014-02-01T21:43:28Z</dcterms:modified>
</cp:coreProperties>
</file>